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8D435"/>
    <a:srgbClr val="92D417"/>
    <a:srgbClr val="84D40C"/>
    <a:srgbClr val="21FF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42" autoAdjust="0"/>
    <p:restoredTop sz="94002" autoAdjust="0"/>
  </p:normalViewPr>
  <p:slideViewPr>
    <p:cSldViewPr snapToGrid="0" snapToObjects="1">
      <p:cViewPr varScale="1">
        <p:scale>
          <a:sx n="117" d="100"/>
          <a:sy n="117" d="100"/>
        </p:scale>
        <p:origin x="2456" y="17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C23799-F4CB-9644-AE8E-524D3D5A1B2A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410014-9089-024A-A149-5FD00C825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913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1288D4-233D-DABF-35BB-500D66C54B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D15A2DD1-9BF9-7E6D-E1C9-A574646A5D0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1BB1DEB-4765-C6E2-D4C8-2C6EBC77133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9FB42A-6F3C-9BD6-32EA-BED480A0443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5410014-9089-024A-A149-5FD00C825A6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98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6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8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2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6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13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0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7"/>
            <a:ext cx="1543050" cy="78020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7"/>
            <a:ext cx="4514850" cy="78020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193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814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3"/>
            <a:ext cx="5829300" cy="1816101"/>
          </a:xfrm>
        </p:spPr>
        <p:txBody>
          <a:bodyPr anchor="t"/>
          <a:lstStyle>
            <a:lvl1pPr algn="l">
              <a:defRPr sz="3692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9"/>
            <a:ext cx="5829300" cy="2000250"/>
          </a:xfrm>
        </p:spPr>
        <p:txBody>
          <a:bodyPr anchor="b"/>
          <a:lstStyle>
            <a:lvl1pPr marL="0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1pPr>
            <a:lvl2pPr marL="422041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708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179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23"/>
            <a:ext cx="303014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23"/>
            <a:ext cx="3031332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2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03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43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25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70"/>
            <a:ext cx="2256235" cy="1549400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9"/>
            <a:ext cx="3833813" cy="7804151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71"/>
            <a:ext cx="2256235" cy="6254751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16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87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455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22041" rtl="0" eaLnBrk="1" latinLnBrk="0" hangingPunct="1">
        <a:spcBef>
          <a:spcPct val="0"/>
        </a:spcBef>
        <a:buNone/>
        <a:defRPr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531" indent="-316531" algn="l" defTabSz="422041" rtl="0" eaLnBrk="1" latinLnBrk="0" hangingPunct="1">
        <a:spcBef>
          <a:spcPct val="20000"/>
        </a:spcBef>
        <a:buFont typeface="Arial"/>
        <a:buChar char="•"/>
        <a:defRPr sz="2954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63776" algn="l" defTabSz="422041" rtl="0" eaLnBrk="1" latinLnBrk="0" hangingPunct="1">
        <a:spcBef>
          <a:spcPct val="20000"/>
        </a:spcBef>
        <a:buFont typeface="Arial"/>
        <a:buChar char="–"/>
        <a:defRPr sz="258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422041" rtl="0" eaLnBrk="1" latinLnBrk="0" hangingPunct="1">
        <a:spcBef>
          <a:spcPct val="20000"/>
        </a:spcBef>
        <a:buFont typeface="Arial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422041" rtl="0" eaLnBrk="1" latinLnBrk="0" hangingPunct="1">
        <a:spcBef>
          <a:spcPct val="20000"/>
        </a:spcBef>
        <a:buFont typeface="Arial"/>
        <a:buChar char="–"/>
        <a:defRPr sz="1846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422041" rtl="0" eaLnBrk="1" latinLnBrk="0" hangingPunct="1">
        <a:spcBef>
          <a:spcPct val="20000"/>
        </a:spcBef>
        <a:buFont typeface="Arial"/>
        <a:buChar char="»"/>
        <a:defRPr sz="1846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CED53D-757D-E1A5-E917-38235B725E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08219C71-F3EE-32B2-C249-4AA29FBEAD8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8740"/>
          <a:stretch/>
        </p:blipFill>
        <p:spPr>
          <a:xfrm>
            <a:off x="1436349" y="825821"/>
            <a:ext cx="914400" cy="125172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846B738-A77C-216D-E0D7-07F927C9C03B}"/>
              </a:ext>
            </a:extLst>
          </p:cNvPr>
          <p:cNvSpPr txBox="1"/>
          <p:nvPr/>
        </p:nvSpPr>
        <p:spPr>
          <a:xfrm>
            <a:off x="1816454" y="778553"/>
            <a:ext cx="3064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B24F0BA-2548-C4C2-A13C-BD3A4EDC432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8740"/>
          <a:stretch/>
        </p:blipFill>
        <p:spPr>
          <a:xfrm>
            <a:off x="436488" y="825821"/>
            <a:ext cx="914400" cy="125172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66A266C-66E0-7CA0-D7F9-14E7018A9843}"/>
              </a:ext>
            </a:extLst>
          </p:cNvPr>
          <p:cNvSpPr txBox="1"/>
          <p:nvPr/>
        </p:nvSpPr>
        <p:spPr>
          <a:xfrm>
            <a:off x="681665" y="889881"/>
            <a:ext cx="5517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 = 0.0509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55162EFB-81E7-3C5E-3EC8-E7BCB2FD8BA2}"/>
              </a:ext>
            </a:extLst>
          </p:cNvPr>
          <p:cNvGrpSpPr/>
          <p:nvPr/>
        </p:nvGrpSpPr>
        <p:grpSpPr>
          <a:xfrm>
            <a:off x="4706142" y="669801"/>
            <a:ext cx="1944976" cy="1529162"/>
            <a:chOff x="441540" y="726479"/>
            <a:chExt cx="1633812" cy="128969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4D74CC4-6DB0-425B-D256-A249D69CA398}"/>
                </a:ext>
              </a:extLst>
            </p:cNvPr>
            <p:cNvSpPr txBox="1"/>
            <p:nvPr/>
          </p:nvSpPr>
          <p:spPr>
            <a:xfrm>
              <a:off x="728129" y="726479"/>
              <a:ext cx="1238102" cy="1946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HALLMARK Glycolysi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15B01C6-9E1D-02BD-68FD-BFFCEB1705C4}"/>
                </a:ext>
              </a:extLst>
            </p:cNvPr>
            <p:cNvSpPr txBox="1"/>
            <p:nvPr/>
          </p:nvSpPr>
          <p:spPr>
            <a:xfrm>
              <a:off x="532027" y="1800728"/>
              <a:ext cx="661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034859C-DAC0-044A-1F92-8E0FBACA0D0E}"/>
                </a:ext>
              </a:extLst>
            </p:cNvPr>
            <p:cNvSpPr txBox="1"/>
            <p:nvPr/>
          </p:nvSpPr>
          <p:spPr>
            <a:xfrm>
              <a:off x="1413374" y="1800728"/>
              <a:ext cx="6619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ED5C3C7-F988-4D2A-DA91-BE6592F290E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4825"/>
            <a:stretch/>
          </p:blipFill>
          <p:spPr>
            <a:xfrm>
              <a:off x="587968" y="912108"/>
              <a:ext cx="1375051" cy="92219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D8B3EBD-D659-1D65-0605-DC1C20BB15AA}"/>
                </a:ext>
              </a:extLst>
            </p:cNvPr>
            <p:cNvSpPr txBox="1"/>
            <p:nvPr/>
          </p:nvSpPr>
          <p:spPr>
            <a:xfrm rot="16200000">
              <a:off x="108725" y="1166042"/>
              <a:ext cx="846606" cy="1809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nrichment Score</a:t>
              </a:r>
            </a:p>
          </p:txBody>
        </p:sp>
      </p:grpSp>
      <p:pic>
        <p:nvPicPr>
          <p:cNvPr id="10" name="Picture 9">
            <a:extLst>
              <a:ext uri="{FF2B5EF4-FFF2-40B4-BE49-F238E27FC236}">
                <a16:creationId xmlns:a16="http://schemas.microsoft.com/office/drawing/2014/main" id="{8482DE01-6A2A-CF74-2F64-11A09AFD990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8740"/>
          <a:stretch/>
        </p:blipFill>
        <p:spPr>
          <a:xfrm>
            <a:off x="2436210" y="825821"/>
            <a:ext cx="914400" cy="125172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367353B-4C5C-25A3-2CAD-73449236E47D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8740"/>
          <a:stretch/>
        </p:blipFill>
        <p:spPr>
          <a:xfrm>
            <a:off x="2436210" y="2408204"/>
            <a:ext cx="914400" cy="125172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4473B5D-5840-C24C-4501-92C8184D3D75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8740"/>
          <a:stretch/>
        </p:blipFill>
        <p:spPr>
          <a:xfrm>
            <a:off x="3436071" y="2408204"/>
            <a:ext cx="914400" cy="125172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B211480-A93E-B032-53D5-BB3EBA7FF7BD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t="8740"/>
          <a:stretch/>
        </p:blipFill>
        <p:spPr>
          <a:xfrm>
            <a:off x="3436071" y="825821"/>
            <a:ext cx="914400" cy="125172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946055A-9DD8-D74E-7DF9-D574A6645B55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t="8740"/>
          <a:stretch/>
        </p:blipFill>
        <p:spPr>
          <a:xfrm>
            <a:off x="1436349" y="2408204"/>
            <a:ext cx="914400" cy="1251725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D49288A-CEF0-B4C3-896A-ACD6FEFBA2FE}"/>
              </a:ext>
            </a:extLst>
          </p:cNvPr>
          <p:cNvSpPr txBox="1"/>
          <p:nvPr/>
        </p:nvSpPr>
        <p:spPr>
          <a:xfrm>
            <a:off x="410237" y="647199"/>
            <a:ext cx="1063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6P/F1P/G6P/G1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89EBB5A-AEC9-7827-671E-240E81EEFB44}"/>
              </a:ext>
            </a:extLst>
          </p:cNvPr>
          <p:cNvSpPr txBox="1"/>
          <p:nvPr/>
        </p:nvSpPr>
        <p:spPr>
          <a:xfrm>
            <a:off x="1726324" y="647199"/>
            <a:ext cx="47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HA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5FA4EE-B732-77DD-82F1-58961E2E9622}"/>
              </a:ext>
            </a:extLst>
          </p:cNvPr>
          <p:cNvSpPr txBox="1"/>
          <p:nvPr/>
        </p:nvSpPr>
        <p:spPr>
          <a:xfrm>
            <a:off x="2782433" y="647199"/>
            <a:ext cx="3914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3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EBEA36F-A17C-F164-F135-A171ADA89DCB}"/>
              </a:ext>
            </a:extLst>
          </p:cNvPr>
          <p:cNvSpPr txBox="1"/>
          <p:nvPr/>
        </p:nvSpPr>
        <p:spPr>
          <a:xfrm>
            <a:off x="3699217" y="647199"/>
            <a:ext cx="5245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8412786-A055-E0C2-0734-272C39400DF3}"/>
              </a:ext>
            </a:extLst>
          </p:cNvPr>
          <p:cNvSpPr txBox="1"/>
          <p:nvPr/>
        </p:nvSpPr>
        <p:spPr>
          <a:xfrm>
            <a:off x="1767324" y="2223445"/>
            <a:ext cx="3850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5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1556BA8-95FB-F373-361A-B1D9FF6887C1}"/>
              </a:ext>
            </a:extLst>
          </p:cNvPr>
          <p:cNvSpPr txBox="1"/>
          <p:nvPr/>
        </p:nvSpPr>
        <p:spPr>
          <a:xfrm>
            <a:off x="2763398" y="2223445"/>
            <a:ext cx="407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0E0C192-C952-E721-66F5-DD1BEA41E9BC}"/>
              </a:ext>
            </a:extLst>
          </p:cNvPr>
          <p:cNvSpPr txBox="1"/>
          <p:nvPr/>
        </p:nvSpPr>
        <p:spPr>
          <a:xfrm>
            <a:off x="3722713" y="2223445"/>
            <a:ext cx="4828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SS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783FFED-C82B-E5C1-41C4-CD99B2B7A705}"/>
              </a:ext>
            </a:extLst>
          </p:cNvPr>
          <p:cNvSpPr txBox="1"/>
          <p:nvPr/>
        </p:nvSpPr>
        <p:spPr>
          <a:xfrm>
            <a:off x="2864358" y="784670"/>
            <a:ext cx="2455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44420C2-A065-6E30-97D0-4130818FA597}"/>
              </a:ext>
            </a:extLst>
          </p:cNvPr>
          <p:cNvSpPr txBox="1"/>
          <p:nvPr/>
        </p:nvSpPr>
        <p:spPr>
          <a:xfrm>
            <a:off x="3815745" y="778553"/>
            <a:ext cx="3064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AAE18B1-0219-287F-BC41-71F171F00CF9}"/>
              </a:ext>
            </a:extLst>
          </p:cNvPr>
          <p:cNvSpPr txBox="1"/>
          <p:nvPr/>
        </p:nvSpPr>
        <p:spPr>
          <a:xfrm>
            <a:off x="1811040" y="2364282"/>
            <a:ext cx="30649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7EADE9A-5057-0CD6-5D71-AF99BC7A559A}"/>
              </a:ext>
            </a:extLst>
          </p:cNvPr>
          <p:cNvSpPr txBox="1"/>
          <p:nvPr/>
        </p:nvSpPr>
        <p:spPr>
          <a:xfrm>
            <a:off x="2843711" y="2358915"/>
            <a:ext cx="2455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E78B37F-C3BD-E62C-1D4A-DFF4EA95AF83}"/>
              </a:ext>
            </a:extLst>
          </p:cNvPr>
          <p:cNvSpPr txBox="1"/>
          <p:nvPr/>
        </p:nvSpPr>
        <p:spPr>
          <a:xfrm>
            <a:off x="3860328" y="2364282"/>
            <a:ext cx="21512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93B7607-AB2F-0823-0A9A-0D1980DED29F}"/>
              </a:ext>
            </a:extLst>
          </p:cNvPr>
          <p:cNvSpPr txBox="1"/>
          <p:nvPr/>
        </p:nvSpPr>
        <p:spPr>
          <a:xfrm>
            <a:off x="60994" y="38787"/>
            <a:ext cx="59198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upplementary Figure 1. GLUT1 overexpression in TCGA HNSCC tumor samples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21FBBC99-DA0B-8472-0DFF-81AD178BE463}"/>
              </a:ext>
            </a:extLst>
          </p:cNvPr>
          <p:cNvGrpSpPr/>
          <p:nvPr/>
        </p:nvGrpSpPr>
        <p:grpSpPr>
          <a:xfrm>
            <a:off x="311107" y="2469626"/>
            <a:ext cx="1187319" cy="396050"/>
            <a:chOff x="2318197" y="2235897"/>
            <a:chExt cx="1187319" cy="39605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5CD3D50-A174-81E3-787D-A4F0565E2085}"/>
                </a:ext>
              </a:extLst>
            </p:cNvPr>
            <p:cNvGrpSpPr/>
            <p:nvPr/>
          </p:nvGrpSpPr>
          <p:grpSpPr>
            <a:xfrm>
              <a:off x="2318197" y="2317359"/>
              <a:ext cx="76131" cy="71733"/>
              <a:chOff x="6087695" y="2707477"/>
              <a:chExt cx="232970" cy="260148"/>
            </a:xfrm>
          </p:grpSpPr>
          <p:sp>
            <p:nvSpPr>
              <p:cNvPr id="34" name="Teardrop 33">
                <a:extLst>
                  <a:ext uri="{FF2B5EF4-FFF2-40B4-BE49-F238E27FC236}">
                    <a16:creationId xmlns:a16="http://schemas.microsoft.com/office/drawing/2014/main" id="{6C3555A0-2878-AE14-4DE5-2CC27FC2DD91}"/>
                  </a:ext>
                </a:extLst>
              </p:cNvPr>
              <p:cNvSpPr/>
              <p:nvPr/>
            </p:nvSpPr>
            <p:spPr>
              <a:xfrm rot="18801298">
                <a:off x="6084438" y="2710734"/>
                <a:ext cx="235455" cy="228941"/>
              </a:xfrm>
              <a:prstGeom prst="teardrop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Teardrop 34">
                <a:extLst>
                  <a:ext uri="{FF2B5EF4-FFF2-40B4-BE49-F238E27FC236}">
                    <a16:creationId xmlns:a16="http://schemas.microsoft.com/office/drawing/2014/main" id="{D879B152-E1D9-5DE9-33B4-5B06FDB94E8A}"/>
                  </a:ext>
                </a:extLst>
              </p:cNvPr>
              <p:cNvSpPr/>
              <p:nvPr/>
            </p:nvSpPr>
            <p:spPr>
              <a:xfrm rot="7894339">
                <a:off x="6088467" y="2735427"/>
                <a:ext cx="235455" cy="228941"/>
              </a:xfrm>
              <a:prstGeom prst="teardrop">
                <a:avLst/>
              </a:prstGeom>
              <a:solidFill>
                <a:srgbClr val="FF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825F118-2F86-A396-2ED5-B1438E9ACF1C}"/>
                </a:ext>
              </a:extLst>
            </p:cNvPr>
            <p:cNvGrpSpPr/>
            <p:nvPr/>
          </p:nvGrpSpPr>
          <p:grpSpPr>
            <a:xfrm>
              <a:off x="2318197" y="2446924"/>
              <a:ext cx="76131" cy="71733"/>
              <a:chOff x="6087695" y="2707477"/>
              <a:chExt cx="232970" cy="260148"/>
            </a:xfrm>
            <a:solidFill>
              <a:srgbClr val="002060"/>
            </a:solidFill>
          </p:grpSpPr>
          <p:sp>
            <p:nvSpPr>
              <p:cNvPr id="37" name="Teardrop 36">
                <a:extLst>
                  <a:ext uri="{FF2B5EF4-FFF2-40B4-BE49-F238E27FC236}">
                    <a16:creationId xmlns:a16="http://schemas.microsoft.com/office/drawing/2014/main" id="{9E2A4D5D-5A22-0F2E-AD13-B5E6E2F60F8A}"/>
                  </a:ext>
                </a:extLst>
              </p:cNvPr>
              <p:cNvSpPr/>
              <p:nvPr/>
            </p:nvSpPr>
            <p:spPr>
              <a:xfrm rot="18801298">
                <a:off x="6084438" y="2710734"/>
                <a:ext cx="235455" cy="228941"/>
              </a:xfrm>
              <a:prstGeom prst="teardrop">
                <a:avLst/>
              </a:prstGeom>
              <a:grpFill/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ardrop 37">
                <a:extLst>
                  <a:ext uri="{FF2B5EF4-FFF2-40B4-BE49-F238E27FC236}">
                    <a16:creationId xmlns:a16="http://schemas.microsoft.com/office/drawing/2014/main" id="{9A6112B5-C636-EF5B-445E-F7E6C47142B8}"/>
                  </a:ext>
                </a:extLst>
              </p:cNvPr>
              <p:cNvSpPr/>
              <p:nvPr/>
            </p:nvSpPr>
            <p:spPr>
              <a:xfrm rot="7894339">
                <a:off x="6088467" y="2735427"/>
                <a:ext cx="235455" cy="228941"/>
              </a:xfrm>
              <a:prstGeom prst="teardrop">
                <a:avLst/>
              </a:prstGeom>
              <a:grpFill/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3346B31-1EEF-2865-63CE-BA5D4FC20401}"/>
                </a:ext>
              </a:extLst>
            </p:cNvPr>
            <p:cNvSpPr txBox="1"/>
            <p:nvPr/>
          </p:nvSpPr>
          <p:spPr>
            <a:xfrm>
              <a:off x="2357183" y="2235897"/>
              <a:ext cx="10224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NSCC (n=34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11C704B-6E6F-8ADE-298B-A4F5DA21D6A8}"/>
                </a:ext>
              </a:extLst>
            </p:cNvPr>
            <p:cNvSpPr txBox="1"/>
            <p:nvPr/>
          </p:nvSpPr>
          <p:spPr>
            <a:xfrm>
              <a:off x="2347827" y="2416503"/>
              <a:ext cx="11576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n-HNSCC (n=893)</a:t>
              </a:r>
            </a:p>
          </p:txBody>
        </p:sp>
      </p:grpSp>
      <p:sp>
        <p:nvSpPr>
          <p:cNvPr id="41" name="Rectangle 40">
            <a:extLst>
              <a:ext uri="{FF2B5EF4-FFF2-40B4-BE49-F238E27FC236}">
                <a16:creationId xmlns:a16="http://schemas.microsoft.com/office/drawing/2014/main" id="{C223DFB7-A6EB-F286-B5CD-565EB4F0EE55}"/>
              </a:ext>
            </a:extLst>
          </p:cNvPr>
          <p:cNvSpPr/>
          <p:nvPr/>
        </p:nvSpPr>
        <p:spPr>
          <a:xfrm>
            <a:off x="4579391" y="473144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B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C8E050E4-AE58-EE8E-C86E-CB1AB1E1274D}"/>
              </a:ext>
            </a:extLst>
          </p:cNvPr>
          <p:cNvSpPr/>
          <p:nvPr/>
        </p:nvSpPr>
        <p:spPr>
          <a:xfrm>
            <a:off x="199192" y="478902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A 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AD982286-7CAF-C0FB-A929-19F489776A7E}"/>
              </a:ext>
            </a:extLst>
          </p:cNvPr>
          <p:cNvSpPr/>
          <p:nvPr/>
        </p:nvSpPr>
        <p:spPr>
          <a:xfrm>
            <a:off x="199200" y="3858247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C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DECB538-799C-ECEC-1629-BDE0649AB99F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12856" b="9707"/>
          <a:stretch/>
        </p:blipFill>
        <p:spPr>
          <a:xfrm>
            <a:off x="4676802" y="4255556"/>
            <a:ext cx="702183" cy="970062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D43E2A6E-B5E6-AB75-B473-9C6ED8437057}"/>
              </a:ext>
            </a:extLst>
          </p:cNvPr>
          <p:cNvSpPr txBox="1"/>
          <p:nvPr/>
        </p:nvSpPr>
        <p:spPr>
          <a:xfrm>
            <a:off x="4869445" y="4148708"/>
            <a:ext cx="3064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pic>
        <p:nvPicPr>
          <p:cNvPr id="62" name="Picture 61" descr="A blue and red sound waves&#10;&#10;Description automatically generated">
            <a:extLst>
              <a:ext uri="{FF2B5EF4-FFF2-40B4-BE49-F238E27FC236}">
                <a16:creationId xmlns:a16="http://schemas.microsoft.com/office/drawing/2014/main" id="{8AC54DB4-AD5F-7AAF-8D64-5859C7F96E0F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7094" b="6410"/>
          <a:stretch/>
        </p:blipFill>
        <p:spPr>
          <a:xfrm>
            <a:off x="111962" y="4276089"/>
            <a:ext cx="3149793" cy="1702774"/>
          </a:xfrm>
          <a:prstGeom prst="rect">
            <a:avLst/>
          </a:prstGeom>
        </p:spPr>
      </p:pic>
      <p:pic>
        <p:nvPicPr>
          <p:cNvPr id="63" name="Picture 62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F33CAF80-A2FD-40A7-BE1C-9CFADBFC49C1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17364" t="5257" b="8248"/>
          <a:stretch/>
        </p:blipFill>
        <p:spPr>
          <a:xfrm>
            <a:off x="3617046" y="4268256"/>
            <a:ext cx="543997" cy="949002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B1FF1404-0170-C157-2898-051E8170673D}"/>
              </a:ext>
            </a:extLst>
          </p:cNvPr>
          <p:cNvSpPr txBox="1"/>
          <p:nvPr/>
        </p:nvSpPr>
        <p:spPr>
          <a:xfrm rot="16200000">
            <a:off x="2942301" y="4648824"/>
            <a:ext cx="928459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SLC2A1 log</a:t>
            </a:r>
            <a:r>
              <a:rPr lang="en-US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TPM+1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76B07A9-FA56-B9A3-C9EE-6A8D62E39D75}"/>
              </a:ext>
            </a:extLst>
          </p:cNvPr>
          <p:cNvSpPr txBox="1"/>
          <p:nvPr/>
        </p:nvSpPr>
        <p:spPr>
          <a:xfrm>
            <a:off x="3497707" y="5187870"/>
            <a:ext cx="460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=6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97379E9-DF75-12BB-0B98-A193563CA098}"/>
              </a:ext>
            </a:extLst>
          </p:cNvPr>
          <p:cNvSpPr txBox="1"/>
          <p:nvPr/>
        </p:nvSpPr>
        <p:spPr>
          <a:xfrm>
            <a:off x="3811989" y="5187870"/>
            <a:ext cx="445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=1453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5F2F67E7-2CBB-EF81-73DE-E6E3F55FB5D6}"/>
              </a:ext>
            </a:extLst>
          </p:cNvPr>
          <p:cNvGrpSpPr/>
          <p:nvPr/>
        </p:nvGrpSpPr>
        <p:grpSpPr>
          <a:xfrm>
            <a:off x="3742738" y="4160474"/>
            <a:ext cx="306494" cy="271370"/>
            <a:chOff x="5984347" y="3468898"/>
            <a:chExt cx="306494" cy="271370"/>
          </a:xfrm>
        </p:grpSpPr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480F207F-FB2E-D857-CD94-267C9E47150B}"/>
                </a:ext>
              </a:extLst>
            </p:cNvPr>
            <p:cNvCxnSpPr>
              <a:cxnSpLocks/>
            </p:cNvCxnSpPr>
            <p:nvPr/>
          </p:nvCxnSpPr>
          <p:spPr>
            <a:xfrm>
              <a:off x="6009083" y="3596295"/>
              <a:ext cx="0" cy="143973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C9D44165-B2F3-4A4E-2063-40550048E4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009083" y="3592817"/>
              <a:ext cx="23561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A7192257-472F-18B2-C3A2-465226BECADE}"/>
                </a:ext>
              </a:extLst>
            </p:cNvPr>
            <p:cNvCxnSpPr>
              <a:cxnSpLocks/>
            </p:cNvCxnSpPr>
            <p:nvPr/>
          </p:nvCxnSpPr>
          <p:spPr>
            <a:xfrm>
              <a:off x="6245508" y="3590419"/>
              <a:ext cx="0" cy="4572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0A76B86-B1D1-E8CA-E6A1-2596504AF995}"/>
                </a:ext>
              </a:extLst>
            </p:cNvPr>
            <p:cNvSpPr txBox="1"/>
            <p:nvPr/>
          </p:nvSpPr>
          <p:spPr>
            <a:xfrm>
              <a:off x="5984347" y="3468898"/>
              <a:ext cx="30649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F83D3101-4E76-B094-19C3-B6C9DD0BA2A0}"/>
              </a:ext>
            </a:extLst>
          </p:cNvPr>
          <p:cNvSpPr txBox="1"/>
          <p:nvPr/>
        </p:nvSpPr>
        <p:spPr>
          <a:xfrm>
            <a:off x="3476994" y="5088435"/>
            <a:ext cx="22794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F932748-56DB-0CD2-65EF-C66FD1AE3434}"/>
              </a:ext>
            </a:extLst>
          </p:cNvPr>
          <p:cNvSpPr txBox="1"/>
          <p:nvPr/>
        </p:nvSpPr>
        <p:spPr>
          <a:xfrm>
            <a:off x="3412873" y="4950890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6BF565D-3E80-5086-EEDB-A07CC99ECFF9}"/>
              </a:ext>
            </a:extLst>
          </p:cNvPr>
          <p:cNvSpPr txBox="1"/>
          <p:nvPr/>
        </p:nvSpPr>
        <p:spPr>
          <a:xfrm>
            <a:off x="3412873" y="4762494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9BA867D-C3A2-5303-21DC-C79F06A67E50}"/>
              </a:ext>
            </a:extLst>
          </p:cNvPr>
          <p:cNvSpPr txBox="1"/>
          <p:nvPr/>
        </p:nvSpPr>
        <p:spPr>
          <a:xfrm>
            <a:off x="3412873" y="4574097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7.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0488CDF-113C-184F-80DB-BBFC3DAACB87}"/>
              </a:ext>
            </a:extLst>
          </p:cNvPr>
          <p:cNvSpPr txBox="1"/>
          <p:nvPr/>
        </p:nvSpPr>
        <p:spPr>
          <a:xfrm>
            <a:off x="3369593" y="4385700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2AEE5AD-1098-8088-350A-1FEF63E9593A}"/>
              </a:ext>
            </a:extLst>
          </p:cNvPr>
          <p:cNvSpPr txBox="1"/>
          <p:nvPr/>
        </p:nvSpPr>
        <p:spPr>
          <a:xfrm>
            <a:off x="3369593" y="4197303"/>
            <a:ext cx="3353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2.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C45BE7A-DA2A-993D-1D3D-CBD2FC6467D9}"/>
              </a:ext>
            </a:extLst>
          </p:cNvPr>
          <p:cNvSpPr txBox="1"/>
          <p:nvPr/>
        </p:nvSpPr>
        <p:spPr>
          <a:xfrm>
            <a:off x="895020" y="4052812"/>
            <a:ext cx="19479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LUT1 Expression in CCLE Cell Lines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3137340F-8F52-5C5F-1473-3146F60AE2D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523574" y="4052812"/>
            <a:ext cx="1280160" cy="1737360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6CD7E94D-2E90-9519-9482-2EE13B96577A}"/>
              </a:ext>
            </a:extLst>
          </p:cNvPr>
          <p:cNvSpPr txBox="1"/>
          <p:nvPr/>
        </p:nvSpPr>
        <p:spPr>
          <a:xfrm>
            <a:off x="4492136" y="489594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BF1C068-34E9-17B4-8D38-D252F9365038}"/>
              </a:ext>
            </a:extLst>
          </p:cNvPr>
          <p:cNvSpPr txBox="1"/>
          <p:nvPr/>
        </p:nvSpPr>
        <p:spPr>
          <a:xfrm>
            <a:off x="4493985" y="464571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AAB8852-FD84-5441-E870-1A3A79746444}"/>
              </a:ext>
            </a:extLst>
          </p:cNvPr>
          <p:cNvSpPr txBox="1"/>
          <p:nvPr/>
        </p:nvSpPr>
        <p:spPr>
          <a:xfrm>
            <a:off x="4492136" y="439547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00905CB-E8BE-6D44-BD74-778EB4BF5378}"/>
              </a:ext>
            </a:extLst>
          </p:cNvPr>
          <p:cNvSpPr txBox="1"/>
          <p:nvPr/>
        </p:nvSpPr>
        <p:spPr>
          <a:xfrm rot="16200000">
            <a:off x="3947369" y="4666430"/>
            <a:ext cx="11015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GLUT1 log</a:t>
            </a:r>
            <a:r>
              <a:rPr lang="en-US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(MS1 intensity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9775946-8035-7B11-BC77-6A173CDF280E}"/>
              </a:ext>
            </a:extLst>
          </p:cNvPr>
          <p:cNvSpPr txBox="1"/>
          <p:nvPr/>
        </p:nvSpPr>
        <p:spPr>
          <a:xfrm>
            <a:off x="4646800" y="5187870"/>
            <a:ext cx="460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HNSCC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=109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6B3B8C1-BA26-FB35-18A4-21ED9D7215E3}"/>
              </a:ext>
            </a:extLst>
          </p:cNvPr>
          <p:cNvSpPr txBox="1"/>
          <p:nvPr/>
        </p:nvSpPr>
        <p:spPr>
          <a:xfrm>
            <a:off x="4959211" y="5187870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</a:p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n=63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0AA82429-050A-9B32-9874-9EEA722EECF9}"/>
              </a:ext>
            </a:extLst>
          </p:cNvPr>
          <p:cNvCxnSpPr>
            <a:cxnSpLocks/>
          </p:cNvCxnSpPr>
          <p:nvPr/>
        </p:nvCxnSpPr>
        <p:spPr>
          <a:xfrm>
            <a:off x="4878353" y="4276088"/>
            <a:ext cx="0" cy="3657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ACFCD339-F0E5-9BFE-FFAC-FED1BFF75B17}"/>
              </a:ext>
            </a:extLst>
          </p:cNvPr>
          <p:cNvCxnSpPr>
            <a:cxnSpLocks/>
          </p:cNvCxnSpPr>
          <p:nvPr/>
        </p:nvCxnSpPr>
        <p:spPr>
          <a:xfrm flipH="1">
            <a:off x="4875178" y="4272627"/>
            <a:ext cx="30076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0EC03A3B-926B-A589-071D-86AA147423A8}"/>
              </a:ext>
            </a:extLst>
          </p:cNvPr>
          <p:cNvCxnSpPr>
            <a:cxnSpLocks/>
          </p:cNvCxnSpPr>
          <p:nvPr/>
        </p:nvCxnSpPr>
        <p:spPr>
          <a:xfrm>
            <a:off x="5178231" y="4270229"/>
            <a:ext cx="0" cy="34852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73D1ABBA-9F4A-673A-B09F-2FBA5D59F469}"/>
              </a:ext>
            </a:extLst>
          </p:cNvPr>
          <p:cNvSpPr/>
          <p:nvPr/>
        </p:nvSpPr>
        <p:spPr>
          <a:xfrm>
            <a:off x="3286940" y="3858247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D 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11141CFB-6B81-4459-B551-F3AC0918EB2B}"/>
              </a:ext>
            </a:extLst>
          </p:cNvPr>
          <p:cNvSpPr/>
          <p:nvPr/>
        </p:nvSpPr>
        <p:spPr>
          <a:xfrm>
            <a:off x="4408420" y="3852286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E 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80DC1F53-AB40-5747-4ADD-FDBB66CEF855}"/>
              </a:ext>
            </a:extLst>
          </p:cNvPr>
          <p:cNvSpPr/>
          <p:nvPr/>
        </p:nvSpPr>
        <p:spPr>
          <a:xfrm>
            <a:off x="5471048" y="3858247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F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93BFA29-7D3E-36ED-2EED-53A019F1358E}"/>
              </a:ext>
            </a:extLst>
          </p:cNvPr>
          <p:cNvSpPr txBox="1"/>
          <p:nvPr/>
        </p:nvSpPr>
        <p:spPr>
          <a:xfrm>
            <a:off x="247584" y="6197212"/>
            <a:ext cx="6318199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1.</a:t>
            </a: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GLUT1 overexpression in TCGA HNSCC tumor samples.</a:t>
            </a:r>
            <a:endParaRPr lang="en-US" sz="12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(A) Violin plots comparing the abundance of metabolites (log</a:t>
            </a:r>
            <a:r>
              <a:rPr lang="en-US" sz="1200" baseline="-250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10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 scale) in HNSCC versus non-HNSCC cell lines. Data obtained from </a:t>
            </a:r>
            <a:r>
              <a:rPr lang="en-US" sz="1200" dirty="0" err="1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DepMa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 Public 24Q2 release. Dots represent individual cell lines. Welch’s two-sample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t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-test was performed to assess statistical significance. ****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&lt;0.0001, ***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&lt;0.001, **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&lt;0.01, *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&lt;0.05. (B) Mountain plot from gene set enrichment analysis (GSEA) showing enrichment of genes belonging to the HALLMARK glycolysis gene set in HNSCC relative to normal tissue (TCGA).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=0.029. NES, Normalized enrichment score. (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C) Violin plots depicting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SLC2A1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(GLUT1) expression in CCLE cell lines stratified by lineage. Lineages are ordered by descending mean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SLC2A1 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expression, and HNSCC is highlighted in red.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(D) Violin plot comparing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SLC2A1 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(GLUT1) mRNA expression in CCLE HNSCC cell lines with all other CCLE cell lines. Dots represent individual cell lines. Welch’s 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t-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test. ****</a:t>
            </a:r>
            <a:r>
              <a:rPr lang="en-US" sz="1200" i="1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&lt;0.0001.</a:t>
            </a:r>
            <a:r>
              <a:rPr lang="en-US" sz="1200" dirty="0">
                <a:solidFill>
                  <a:srgbClr val="FF0000"/>
                </a:solidFill>
                <a:effectLst/>
                <a:ea typeface="MS Mincho" panose="02020609040205080304" pitchFamily="49" charset="-128"/>
              </a:rPr>
              <a:t> </a:t>
            </a:r>
            <a:r>
              <a:rPr lang="en-US" sz="1200" dirty="0">
                <a:effectLst/>
                <a:ea typeface="MS Mincho" panose="02020609040205080304" pitchFamily="49" charset="-128"/>
              </a:rPr>
              <a:t>(E)</a:t>
            </a:r>
            <a:r>
              <a:rPr lang="en-US" sz="1200" dirty="0">
                <a:solidFill>
                  <a:srgbClr val="FF0000"/>
                </a:solidFill>
                <a:effectLst/>
                <a:ea typeface="MS Mincho" panose="02020609040205080304" pitchFamily="49" charset="-128"/>
              </a:rPr>
              <a:t> </a:t>
            </a:r>
            <a:r>
              <a:rPr lang="en-US" sz="1200" dirty="0">
                <a:effectLst/>
                <a:ea typeface="MS Mincho" panose="02020609040205080304" pitchFamily="49" charset="-128"/>
              </a:rPr>
              <a:t>Violin plot comparing GLUT1 protein expression in HNSCC tumors to normal tissue from CPTAC proteomics data. Dots represent individual tumor or normal tissue samples. Welch’s </a:t>
            </a:r>
            <a:r>
              <a:rPr lang="en-US" sz="1200" i="1" dirty="0">
                <a:effectLst/>
                <a:ea typeface="MS Mincho" panose="02020609040205080304" pitchFamily="49" charset="-128"/>
              </a:rPr>
              <a:t>t</a:t>
            </a:r>
            <a:r>
              <a:rPr lang="en-US" sz="1200" dirty="0">
                <a:effectLst/>
                <a:ea typeface="MS Mincho" panose="02020609040205080304" pitchFamily="49" charset="-128"/>
              </a:rPr>
              <a:t>-test. ****</a:t>
            </a:r>
            <a:r>
              <a:rPr lang="en-US" sz="1200" i="1" dirty="0">
                <a:effectLst/>
                <a:ea typeface="MS Mincho" panose="02020609040205080304" pitchFamily="49" charset="-128"/>
              </a:rPr>
              <a:t>P</a:t>
            </a:r>
            <a:r>
              <a:rPr lang="en-US" sz="1200" dirty="0">
                <a:effectLst/>
                <a:ea typeface="MS Mincho" panose="02020609040205080304" pitchFamily="49" charset="-128"/>
              </a:rPr>
              <a:t>&lt;0.0001. </a:t>
            </a:r>
            <a:r>
              <a:rPr lang="en-US" sz="1200" dirty="0">
                <a:solidFill>
                  <a:srgbClr val="000000"/>
                </a:solidFill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(F) Comparison of GLUT1 expression in HPV- (n=410), HPV+ (n=72) and matched normal (n=44) tissue samples from the TCGA mRNA-sequencing data (TPM).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63731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514</TotalTime>
  <Words>373</Words>
  <Application>Microsoft Macintosh PowerPoint</Application>
  <PresentationFormat>Letter Paper (8.5x11 in)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Montemayor</dc:creator>
  <cp:lastModifiedBy>Kim, Jay</cp:lastModifiedBy>
  <cp:revision>1013</cp:revision>
  <cp:lastPrinted>2024-10-14T15:59:24Z</cp:lastPrinted>
  <dcterms:created xsi:type="dcterms:W3CDTF">2019-09-25T12:49:47Z</dcterms:created>
  <dcterms:modified xsi:type="dcterms:W3CDTF">2025-04-15T20:32:55Z</dcterms:modified>
</cp:coreProperties>
</file>